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15"/>
    <p:restoredTop sz="94646"/>
  </p:normalViewPr>
  <p:slideViewPr>
    <p:cSldViewPr snapToGrid="0" snapToObjects="1">
      <p:cViewPr varScale="1">
        <p:scale>
          <a:sx n="100" d="100"/>
          <a:sy n="100" d="100"/>
        </p:scale>
        <p:origin x="192" y="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A50CD0E-FF6A-D04B-80F3-C25A5F99D2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08E1AE2E-430F-1B4A-AB3A-734FC37C045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6A38ECD-44EB-C842-AF28-8378702434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9F56E57-793D-A44F-A8DD-07AE5D48C1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A6E211C-47FF-0E40-BDFF-2A6428127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74066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FF89106-35D5-7D4D-970C-37B308412A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8BA87E1C-9AD7-4C41-960F-FA25B13BB57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2407D74-A5D6-A44A-92AD-53BAF03F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131AD2A-CB85-C249-9A78-2B4D34635A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5F2D278-09EF-884A-8483-C564E0D2E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066671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63BC1C19-2D67-0341-A8D5-B7D2AA027E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00633AB4-5C77-9840-A4A9-B7B2A55BEF2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068305D-9C6D-3B44-87B8-C09CEA0070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C2739A8-234D-1249-BA7E-81E94B8DE2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48B0A75-76A9-3244-8F3E-4E7656D325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209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DFBD20F-E6E9-A145-A1B9-3798AD6351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769D8C0C-DF8E-5F49-AE63-45173C7DE31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824A834-DC1C-A640-93D1-72B8174AD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2826C94-BDD9-CB45-B03B-28DFFE1EAE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DC4D5A4-E64B-3F44-BB7C-9DD024E98A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2481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C5E246-FDBA-7C42-A047-D6F0C42DD8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A419BB-DC8C-364A-B337-E034C45048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889EF59-FE31-AE41-8DCF-1CA4A4E4BC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F12A2DA-8CDB-6447-A6B1-6EC6A85C2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E97F7C3-DF20-E245-A042-61E8A19497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50316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57C886E-81AC-0F42-AA73-1AC5457B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F4396F9-4CE8-EE42-8071-D3239B731D9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0841B8B-A7BA-C344-B4E8-CA6BE5EFF7E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765C8D8F-ED24-1042-A30F-05CF12BBBD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70A4E5C-3B59-0446-AB00-9470D42631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1657F57F-2902-2F46-B2CB-8376FACF6E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65987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03B5C54-D368-7D46-98DD-2978C344FA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82B758C-540A-D54D-8A7E-4E74856F57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AA9C1BA-3088-F34C-BA2F-EEF9E2FDCFD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B9549DBF-C949-624D-97AB-D80B65D8E73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1CA131E-69E0-C946-91C9-568B4BD06A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DF0A3455-E48A-C342-B915-A54D3A6270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56C9600A-FF6C-BD48-A184-9C226B69BB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933DE63D-D992-EF47-8EFF-CDD93750E6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5634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8E0E1533-4DAD-F442-8D53-3244BDE2C6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804329AC-A143-E045-81C8-4F8CB77BDD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00EA9AB-1120-B94E-9AEB-1789CD9377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8277D8FB-CCC7-1541-BB2F-C5ED8762CA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42239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F03BD2E0-5E5D-F44A-B9E3-BE4A702651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31D92BC-33AE-2548-B2C6-6298ABD9FF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9A552E23-F0AB-6741-8A29-B7DB10925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78766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932AE27-85EF-3747-A8A5-F985FF4E5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8B18D9A9-F6AB-3243-A78B-38E28709CDE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ED6A77-473C-C04E-8367-3A3AC757E5B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7A60C71-9C8B-0743-A9C4-D24B69F60E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812050B-509D-5448-BC1E-8B52AA46BE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C9BDC6F0-EBB2-B242-AD99-16FB9B7D01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6412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AE59AC6-E14F-AE48-9290-B7ED3D7ECB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ACC9D21-C80F-0C40-9283-3D992625571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3CF617-E74C-EE46-A371-9BB225C9B9D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8E1C1072-E4C8-3D43-95F3-C0A31EFCCF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3B6F9CF-A589-464E-BC63-6AEBC807C1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34DC5DD4-0612-CD4D-8D3F-7FC772215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1197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988184EC-D380-AE4B-9D65-D27CF8B374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8942248-9E24-2A43-999E-6CD5A1E50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C79A242-F08B-9446-A2F9-0CE9F50291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7A284C-FEF4-3E40-BE0D-E39187099914}" type="datetimeFigureOut">
              <a:rPr lang="fr-FR" smtClean="0"/>
              <a:t>25/05/2020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0EA4323-C73E-A647-B34E-44C0047B33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F824B2-7300-9B46-A90E-665FF49EECE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7DF296-FA37-7B4D-A21E-3A578BA992CB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46423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>
            <a:extLst>
              <a:ext uri="{FF2B5EF4-FFF2-40B4-BE49-F238E27FC236}">
                <a16:creationId xmlns:a16="http://schemas.microsoft.com/office/drawing/2014/main" id="{9A0CC2A4-DBAA-8342-B56C-286F4873615C}"/>
              </a:ext>
            </a:extLst>
          </p:cNvPr>
          <p:cNvSpPr txBox="1"/>
          <p:nvPr/>
        </p:nvSpPr>
        <p:spPr>
          <a:xfrm>
            <a:off x="0" y="15103"/>
            <a:ext cx="1219200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1: Gpr101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express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motes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G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/Igf-1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Prolacti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hypersecretion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keletal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overgrowth</a:t>
            </a:r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in vivo</a:t>
            </a:r>
          </a:p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Panel A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Immunofluorescenc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–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localisation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FLAG-Gpr101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n 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terior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pituitary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400" i="1" dirty="0"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Gpr101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(29-week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l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n=4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animal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, males and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female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  <a:p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Confoca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microscope – Nikon A1R-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Oil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immersion objective - x60 magnification – Zoom 2</a:t>
            </a:r>
          </a:p>
          <a:p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experiment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400" dirty="0" err="1">
                <a:latin typeface="Arial" panose="020B0604020202020204" pitchFamily="34" charset="0"/>
                <a:cs typeface="Arial" panose="020B0604020202020204" pitchFamily="34" charset="0"/>
              </a:rPr>
              <a:t>repeated</a:t>
            </a:r>
            <a:r>
              <a:rPr lang="fr-FR" sz="1400" dirty="0">
                <a:latin typeface="Arial" panose="020B0604020202020204" pitchFamily="34" charset="0"/>
                <a:cs typeface="Arial" panose="020B0604020202020204" pitchFamily="34" charset="0"/>
              </a:rPr>
              <a:t> at least 3 times</a:t>
            </a:r>
          </a:p>
        </p:txBody>
      </p:sp>
      <p:pic>
        <p:nvPicPr>
          <p:cNvPr id="5" name="Image 4">
            <a:extLst>
              <a:ext uri="{FF2B5EF4-FFF2-40B4-BE49-F238E27FC236}">
                <a16:creationId xmlns:a16="http://schemas.microsoft.com/office/drawing/2014/main" id="{EC5BC314-DEDF-7C45-BF6F-B75B5663341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12655" y="1433015"/>
            <a:ext cx="2433482" cy="2443044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5B043428-F936-4647-9EEF-FC1705B1587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83445" y="4026089"/>
            <a:ext cx="2438253" cy="2443044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585AA7AE-163C-3244-B664-9F4DA9A21A9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112655" y="4026089"/>
            <a:ext cx="2447834" cy="2443044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7D298E13-D7C7-A645-A273-C55CDEDD15EC}"/>
              </a:ext>
            </a:extLst>
          </p:cNvPr>
          <p:cNvSpPr txBox="1"/>
          <p:nvPr/>
        </p:nvSpPr>
        <p:spPr>
          <a:xfrm>
            <a:off x="3112655" y="4026089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</a:t>
            </a:r>
            <a:endParaRPr lang="fr-FR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62BBC823-4E1E-2043-8DF4-FFAB0B628CD0}"/>
              </a:ext>
            </a:extLst>
          </p:cNvPr>
          <p:cNvSpPr txBox="1"/>
          <p:nvPr/>
        </p:nvSpPr>
        <p:spPr>
          <a:xfrm>
            <a:off x="483445" y="4026089"/>
            <a:ext cx="1954381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hrhr</a:t>
            </a:r>
            <a:r>
              <a:rPr lang="fr-FR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647 </a:t>
            </a:r>
            <a:r>
              <a:rPr lang="fr-FR" sz="1400" b="1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B8CAD1D2-D95B-7E4C-8EDF-5C3ACB91BE62}"/>
              </a:ext>
            </a:extLst>
          </p:cNvPr>
          <p:cNvSpPr txBox="1"/>
          <p:nvPr/>
        </p:nvSpPr>
        <p:spPr>
          <a:xfrm>
            <a:off x="3112656" y="1433015"/>
            <a:ext cx="244783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LAG </a:t>
            </a:r>
          </a:p>
          <a:p>
            <a:r>
              <a:rPr lang="fr-FR" sz="1400" b="1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Alexa Fluor 488 green)</a:t>
            </a:r>
          </a:p>
        </p:txBody>
      </p:sp>
      <p:pic>
        <p:nvPicPr>
          <p:cNvPr id="11" name="Image 10">
            <a:extLst>
              <a:ext uri="{FF2B5EF4-FFF2-40B4-BE49-F238E27FC236}">
                <a16:creationId xmlns:a16="http://schemas.microsoft.com/office/drawing/2014/main" id="{FE7F048E-7BA0-404B-9DAB-163258F0375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83445" y="1433016"/>
            <a:ext cx="2443044" cy="2443044"/>
          </a:xfrm>
          <a:prstGeom prst="rect">
            <a:avLst/>
          </a:prstGeom>
        </p:spPr>
      </p:pic>
      <p:sp>
        <p:nvSpPr>
          <p:cNvPr id="12" name="ZoneTexte 11">
            <a:extLst>
              <a:ext uri="{FF2B5EF4-FFF2-40B4-BE49-F238E27FC236}">
                <a16:creationId xmlns:a16="http://schemas.microsoft.com/office/drawing/2014/main" id="{89B03850-B13C-2C4C-A481-509F4DEB1B24}"/>
              </a:ext>
            </a:extLst>
          </p:cNvPr>
          <p:cNvSpPr txBox="1"/>
          <p:nvPr/>
        </p:nvSpPr>
        <p:spPr>
          <a:xfrm>
            <a:off x="483445" y="1433015"/>
            <a:ext cx="12859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 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fr-FR" sz="1400" b="1" dirty="0" err="1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lue</a:t>
            </a:r>
            <a:r>
              <a:rPr lang="fr-FR" sz="1400" b="1" dirty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17770D42-E1CB-D649-BBC3-9128C2A6CFE7}"/>
              </a:ext>
            </a:extLst>
          </p:cNvPr>
          <p:cNvSpPr txBox="1"/>
          <p:nvPr/>
        </p:nvSpPr>
        <p:spPr>
          <a:xfrm>
            <a:off x="483445" y="6488668"/>
            <a:ext cx="20040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cale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bar </a:t>
            </a:r>
            <a:r>
              <a:rPr lang="fr-FR">
                <a:latin typeface="Arial" panose="020B0604020202020204" pitchFamily="34" charset="0"/>
                <a:cs typeface="Arial" panose="020B0604020202020204" pitchFamily="34" charset="0"/>
              </a:rPr>
              <a:t>= 10µm</a:t>
            </a: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A091BE7-7575-6E4E-A30D-B5E989C1ABA3}"/>
              </a:ext>
            </a:extLst>
          </p:cNvPr>
          <p:cNvSpPr/>
          <p:nvPr/>
        </p:nvSpPr>
        <p:spPr>
          <a:xfrm>
            <a:off x="5751446" y="4899473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</a:t>
            </a:r>
            <a:r>
              <a:rPr lang="en-US" sz="1600" u="sng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Ghrhr</a:t>
            </a:r>
            <a:r>
              <a:rPr lang="en-US" sz="1600" u="sng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anterior pituitary)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P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rimary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Yu Mincho" panose="02020400000000000000" pitchFamily="18" charset="-128"/>
                <a:cs typeface="Arial" panose="020B0604020202020204" pitchFamily="34" charset="0"/>
              </a:rPr>
              <a:t> antibody: polyclonal rabbit 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ti-GHRHR (</a:t>
            </a:r>
            <a:r>
              <a:rPr lang="en-US" sz="1600" dirty="0" err="1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LSBio</a:t>
            </a:r>
            <a:r>
              <a:rPr lang="en-US" sz="1600" dirty="0">
                <a:solidFill>
                  <a:srgbClr val="FF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, Cat. No LS-B6566, dilution </a:t>
            </a:r>
            <a:r>
              <a:rPr lang="en-US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:100)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-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rabbit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H+L) F(ab’)2 fragment Alexa Fluor 647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onjugate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echnology</a:t>
            </a:r>
            <a:r>
              <a:rPr lang="fr-BE" sz="1600" dirty="0">
                <a:solidFill>
                  <a:srgbClr val="FF00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, Cat. No 4414, dilution 1:1000) 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AC10B67-9B7C-C942-B898-8BB4164F67E3}"/>
              </a:ext>
            </a:extLst>
          </p:cNvPr>
          <p:cNvSpPr/>
          <p:nvPr/>
        </p:nvSpPr>
        <p:spPr>
          <a:xfrm>
            <a:off x="5751446" y="1550369"/>
            <a:ext cx="6096000" cy="86177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cell nuclei</a:t>
            </a:r>
            <a:r>
              <a:rPr lang="en-US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nl-BE" sz="1600" dirty="0">
                <a:solidFill>
                  <a:srgbClr val="00B0F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DAPI</a:t>
            </a:r>
            <a:endParaRPr lang="fr-BE" dirty="0">
              <a:solidFill>
                <a:srgbClr val="00B0F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85750" indent="-285750" algn="just">
              <a:buFontTx/>
              <a:buChar char="-"/>
            </a:pPr>
            <a:endParaRPr lang="fr-FR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A6ABDDE-89A1-A540-8102-B6D74187E31A}"/>
              </a:ext>
            </a:extLst>
          </p:cNvPr>
          <p:cNvSpPr/>
          <p:nvPr/>
        </p:nvSpPr>
        <p:spPr>
          <a:xfrm>
            <a:off x="5751446" y="2748816"/>
            <a:ext cx="6096000" cy="156966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sz="1600" u="sng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For the detection of FLAG-Gpr101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:</a:t>
            </a:r>
          </a:p>
          <a:p>
            <a:pPr marL="285750" indent="-285750" algn="just">
              <a:buFontTx/>
              <a:buChar char="-"/>
            </a:pP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imary antibody: monoclonal mouse anti-FLAG antibody (Sigma–Aldrich, Cat. No F3165, clone M2, dilution 1:1000)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marL="285750" indent="-285750" algn="just">
              <a:buFontTx/>
              <a:buChar char="-"/>
            </a:pPr>
            <a:r>
              <a:rPr lang="fr-BE" sz="1600" dirty="0" err="1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econdary</a:t>
            </a:r>
            <a:r>
              <a:rPr lang="fr-BE" sz="1600" dirty="0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BE" sz="1600" dirty="0" err="1">
                <a:solidFill>
                  <a:srgbClr val="00FA00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antibody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: </a:t>
            </a:r>
            <a:r>
              <a:rPr lang="en-US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ti-mouse IgG Fab2 Alexa Fluor 488 conjugate (Cell Signaling Technology, Cat. No 4408S, dilution 1:1000</a:t>
            </a:r>
            <a:r>
              <a:rPr lang="fr-BE" sz="1600" dirty="0">
                <a:solidFill>
                  <a:srgbClr val="00FA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fr-BE" sz="1600" dirty="0">
              <a:solidFill>
                <a:srgbClr val="00FA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216408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</TotalTime>
  <Words>213</Words>
  <Application>Microsoft Macintosh PowerPoint</Application>
  <PresentationFormat>Grand écran</PresentationFormat>
  <Paragraphs>2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Yu Mincho</vt:lpstr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Microsoft Office</dc:creator>
  <cp:lastModifiedBy>Utilisateur Microsoft Office</cp:lastModifiedBy>
  <cp:revision>9</cp:revision>
  <dcterms:created xsi:type="dcterms:W3CDTF">2020-05-09T12:35:08Z</dcterms:created>
  <dcterms:modified xsi:type="dcterms:W3CDTF">2020-05-25T16:52:04Z</dcterms:modified>
</cp:coreProperties>
</file>